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7" r:id="rId3"/>
    <p:sldId id="257" r:id="rId4"/>
    <p:sldId id="258" r:id="rId5"/>
    <p:sldId id="259" r:id="rId6"/>
    <p:sldId id="261" r:id="rId7"/>
    <p:sldId id="262" r:id="rId8"/>
    <p:sldId id="266" r:id="rId9"/>
    <p:sldId id="263" r:id="rId10"/>
    <p:sldId id="264" r:id="rId11"/>
    <p:sldId id="265" r:id="rId12"/>
    <p:sldId id="268" r:id="rId13"/>
    <p:sldId id="269" r:id="rId1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3" d="100"/>
          <a:sy n="123" d="100"/>
        </p:scale>
        <p:origin x="1254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0CEFF-47AB-4896-AE1D-0195F7E154FC}" type="datetimeFigureOut">
              <a:rPr lang="en-US" smtClean="0"/>
              <a:t>12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D19-B11F-4135-9B54-02C4DEF2F0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039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0CEFF-47AB-4896-AE1D-0195F7E154FC}" type="datetimeFigureOut">
              <a:rPr lang="en-US" smtClean="0"/>
              <a:t>12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D19-B11F-4135-9B54-02C4DEF2F0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410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0CEFF-47AB-4896-AE1D-0195F7E154FC}" type="datetimeFigureOut">
              <a:rPr lang="en-US" smtClean="0"/>
              <a:t>12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D19-B11F-4135-9B54-02C4DEF2F0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281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0CEFF-47AB-4896-AE1D-0195F7E154FC}" type="datetimeFigureOut">
              <a:rPr lang="en-US" smtClean="0"/>
              <a:t>12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D19-B11F-4135-9B54-02C4DEF2F0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108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0CEFF-47AB-4896-AE1D-0195F7E154FC}" type="datetimeFigureOut">
              <a:rPr lang="en-US" smtClean="0"/>
              <a:t>12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D19-B11F-4135-9B54-02C4DEF2F0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169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0CEFF-47AB-4896-AE1D-0195F7E154FC}" type="datetimeFigureOut">
              <a:rPr lang="en-US" smtClean="0"/>
              <a:t>12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D19-B11F-4135-9B54-02C4DEF2F0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653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0CEFF-47AB-4896-AE1D-0195F7E154FC}" type="datetimeFigureOut">
              <a:rPr lang="en-US" smtClean="0"/>
              <a:t>12/1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D19-B11F-4135-9B54-02C4DEF2F0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521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0CEFF-47AB-4896-AE1D-0195F7E154FC}" type="datetimeFigureOut">
              <a:rPr lang="en-US" smtClean="0"/>
              <a:t>12/1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D19-B11F-4135-9B54-02C4DEF2F0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861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0CEFF-47AB-4896-AE1D-0195F7E154FC}" type="datetimeFigureOut">
              <a:rPr lang="en-US" smtClean="0"/>
              <a:t>12/1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D19-B11F-4135-9B54-02C4DEF2F0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5752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0CEFF-47AB-4896-AE1D-0195F7E154FC}" type="datetimeFigureOut">
              <a:rPr lang="en-US" smtClean="0"/>
              <a:t>12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D19-B11F-4135-9B54-02C4DEF2F0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184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0CEFF-47AB-4896-AE1D-0195F7E154FC}" type="datetimeFigureOut">
              <a:rPr lang="en-US" smtClean="0"/>
              <a:t>12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D19-B11F-4135-9B54-02C4DEF2F0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078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20CEFF-47AB-4896-AE1D-0195F7E154FC}" type="datetimeFigureOut">
              <a:rPr lang="en-US" smtClean="0"/>
              <a:t>12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B41D19-B11F-4135-9B54-02C4DEF2F0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799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l data</a:t>
            </a:r>
          </a:p>
        </p:txBody>
      </p:sp>
      <p:sp>
        <p:nvSpPr>
          <p:cNvPr id="4" name="Subtitle 3">
            <a:extLst>
              <a:ext uri="{FF2B5EF4-FFF2-40B4-BE49-F238E27FC236}">
                <a16:creationId xmlns:a16="http://schemas.microsoft.com/office/drawing/2014/main" id="{62EFF65C-FAC0-443F-8E36-8DC469FA968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123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5000" y="1219200"/>
            <a:ext cx="5918200" cy="4438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697982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1143000"/>
            <a:ext cx="6299200" cy="472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697982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B91454B6-AC87-4DBB-872B-BA44BBA668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447800" y="2552700"/>
            <a:ext cx="6400800" cy="1752600"/>
          </a:xfrm>
        </p:spPr>
        <p:txBody>
          <a:bodyPr>
            <a:normAutofit fontScale="77500" lnSpcReduction="20000"/>
          </a:bodyPr>
          <a:lstStyle/>
          <a:p>
            <a:r>
              <a:rPr lang="en-US" dirty="0"/>
              <a:t>Effect of Plastic coverslip on the ability of examining tissue</a:t>
            </a:r>
          </a:p>
          <a:p>
            <a:r>
              <a:rPr lang="en-US" dirty="0"/>
              <a:t>Same sample rotated and imaged at same exposure time.  Notice only on angle has a darker field.</a:t>
            </a:r>
          </a:p>
        </p:txBody>
      </p:sp>
    </p:spTree>
    <p:extLst>
      <p:ext uri="{BB962C8B-B14F-4D97-AF65-F5344CB8AC3E}">
        <p14:creationId xmlns:p14="http://schemas.microsoft.com/office/powerpoint/2010/main" val="348576369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45E231E-BB22-4671-968A-297BFCBF13E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219946" y="1150179"/>
            <a:ext cx="2741706" cy="181593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6D9E0F7-066C-4040-BBAA-143EA338FC4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201146" y="1150179"/>
            <a:ext cx="2741707" cy="181593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0C255FD-AD20-4800-9240-0D88DD8F794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218509" y="1150180"/>
            <a:ext cx="2741708" cy="181593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F3F7B98-6DB3-49B6-BB90-2CD7903B5C2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356514" y="4196686"/>
            <a:ext cx="2741709" cy="181593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5DB7063-2569-4B9A-B004-F8867D45216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310994" y="4196686"/>
            <a:ext cx="2741709" cy="18159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35726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>
            <a:extLst>
              <a:ext uri="{FF2B5EF4-FFF2-40B4-BE49-F238E27FC236}">
                <a16:creationId xmlns:a16="http://schemas.microsoft.com/office/drawing/2014/main" id="{C7AFB319-2361-4818-87BF-91388E6281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19200" y="2286000"/>
            <a:ext cx="6400800" cy="1752600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Congo red stained cardiac tissue from different patients which was initially deemed negative using regular microscope.</a:t>
            </a:r>
          </a:p>
        </p:txBody>
      </p:sp>
    </p:spTree>
    <p:extLst>
      <p:ext uri="{BB962C8B-B14F-4D97-AF65-F5344CB8AC3E}">
        <p14:creationId xmlns:p14="http://schemas.microsoft.com/office/powerpoint/2010/main" val="20922386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0" y="1371600"/>
            <a:ext cx="5579123" cy="4184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72240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2000" y="1447800"/>
            <a:ext cx="5283200" cy="396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69798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0" y="1295400"/>
            <a:ext cx="5588000" cy="4191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69798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1200" y="1371600"/>
            <a:ext cx="5689600" cy="426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69798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0" y="1257300"/>
            <a:ext cx="5486400" cy="411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69798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0" y="1219200"/>
            <a:ext cx="5638800" cy="4229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82719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7276" y="1219200"/>
            <a:ext cx="5892800" cy="441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6979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8</Words>
  <Application>Microsoft Office PowerPoint</Application>
  <PresentationFormat>On-screen Show (4:3)</PresentationFormat>
  <Paragraphs>4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6" baseType="lpstr">
      <vt:lpstr>Arial</vt:lpstr>
      <vt:lpstr>Calibri</vt:lpstr>
      <vt:lpstr>Office Theme</vt:lpstr>
      <vt:lpstr>Supplemental dat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-Meanawy, Ashraf</dc:creator>
  <cp:lastModifiedBy>El-Meanawy, Ashraf</cp:lastModifiedBy>
  <cp:revision>3</cp:revision>
  <dcterms:created xsi:type="dcterms:W3CDTF">2018-11-28T21:29:39Z</dcterms:created>
  <dcterms:modified xsi:type="dcterms:W3CDTF">2018-12-11T20:08:59Z</dcterms:modified>
</cp:coreProperties>
</file>